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6" autoAdjust="0"/>
    <p:restoredTop sz="94660"/>
  </p:normalViewPr>
  <p:slideViewPr>
    <p:cSldViewPr snapToGrid="0">
      <p:cViewPr varScale="1">
        <p:scale>
          <a:sx n="96" d="100"/>
          <a:sy n="96" d="100"/>
        </p:scale>
        <p:origin x="77" y="2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5312D9-1BED-4E72-B01A-CE9F19C851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46180A-7DA2-4BE7-B6D8-0F44A37E83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71C1A5-4006-4C4B-95F0-8D04358F6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6DECF3-3A59-48B4-90D8-8C00C40DF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31234-E203-403F-A766-03AD9CB40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96057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407397-156C-42EC-BDE3-7FCFDD824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F4703C-3C11-49CB-B39A-EAF2FDA84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1A601B-7EC9-42E6-AE25-20D5DBF82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197A1B-721E-443D-A2D7-023212DA6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9C6873-10A2-4A45-BA57-5A21172AD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13904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868DCC-7B04-45CA-9FC6-660B27D9F4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A7900C-6D40-4D40-8C1F-34441664EA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32917B-5250-453D-A165-CF9EAF8EC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089D6-3CBC-4143-A6B6-37145285B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040066-5B46-4936-9AF1-F8D331F9F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41681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02316F-7A36-4205-B002-65C4EDE29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BDBD86-1A91-4EC3-A62B-A7CF249C6F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02F6E7-4398-4A9A-8662-599648819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6C700A-B4A9-4256-9FFC-EE837E7EC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4CE9B-17EC-44F0-A10D-B14A93D35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39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CE4F4-E1C3-4F42-A38A-42BF9E001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E47F66-A141-4B2B-9CF5-1C5F4A828E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280E2D-7BBF-4912-88B1-4D326E0D1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A1C6A-EED6-4FE1-9B03-645CBCC0C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E38652-230D-49E2-BD6B-601CE14E4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943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09FFD-3670-49B4-93BA-833EB357B1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57817B-BC59-4302-9EDC-42E102017E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C9276B-EE8C-485A-8BC5-F138291480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5F042-4815-4DB2-9EFE-F652FEFE9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CDCDAE-736E-470A-B4A7-2405DF44B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95DDD5-00FE-485F-9631-28DE536E0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31704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47EE9-F511-436E-A8D0-FC88535F76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2CCB6F-174A-4CA5-B53E-7539EED5FE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707E81-306A-4EDB-A3B2-90BBBC4B03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F7277E-E6F5-4613-9532-589D64627D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78A0CA-AA95-45BE-99A1-71721DF11C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EF8047-650E-4235-8273-37928C64C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899F94-B47D-4883-A895-690AEA381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AE7417-F0EE-4027-8812-04C9CEEF4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93944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F9EA4-C3B5-4769-8194-246D6D681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9451CF-052B-420C-AA39-0E699B29B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A3AB04-C555-4665-98E2-752E574C5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B9C9C2-A700-49DD-BE15-66763797F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1854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D200F2-A778-48A4-9D8E-7A6F99306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C1889C-43F9-4B7E-8F9D-9692A8012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8983E0-6E99-4A95-A6C1-2E54641A0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12964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03A6ED-B12C-4842-B5B8-F929A4F27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D076B8-AC2F-4BAF-A76D-CB6A52D581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EE0253-109A-4F2C-8E44-A270D73612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7F83AA-E583-444B-8C70-90D35340B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16E850-8A73-4841-8AFD-538C10D12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A7F2CF-8D60-4747-B298-2E7192048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50546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FE91B-DE0F-4472-8456-AD8316B50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2DCF87-E4A8-4F7C-AD97-37622A2DDD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98006D-AFB6-4D2C-839B-27B09FC26C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9068B8-EFF3-48B9-8CB1-581D417EC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C79218-C031-4C65-82C8-79F0E9D35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B612D0-30D5-475D-9787-DA7E35E1C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04375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CEA8BC-EFC5-480C-A3C9-27BD47529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1D294F-44B8-466F-8865-A1D43ED62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132FAC-A138-4966-9B2F-E6F35D6EA0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0B54B-EE48-40A2-9D91-22857DEA9D7E}" type="datetimeFigureOut">
              <a:rPr lang="en-ZA" smtClean="0"/>
              <a:t>2026/04/2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80EA5-5F4F-4D08-A974-C4454936DD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F1B1B-1CDB-4567-8898-B28ECBE2B5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9089F-2DBE-4682-8446-902780C5EEC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74644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9F38D5-C046-442E-AB41-63B61D8FE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4707172"/>
            <a:ext cx="10540117" cy="659442"/>
          </a:xfrm>
        </p:spPr>
        <p:txBody>
          <a:bodyPr>
            <a:noAutofit/>
          </a:bodyPr>
          <a:lstStyle/>
          <a:p>
            <a:br>
              <a:rPr lang="en-ZA" sz="2800" dirty="0"/>
            </a:br>
            <a:br>
              <a:rPr lang="en-ZA" sz="2800" dirty="0"/>
            </a:br>
            <a:br>
              <a:rPr lang="en-ZA" sz="2800" dirty="0"/>
            </a:br>
            <a:r>
              <a:rPr lang="en-ZA" sz="2800" b="1" dirty="0"/>
              <a:t>Supplementary Figure 3</a:t>
            </a:r>
            <a:r>
              <a:rPr lang="en-ZA" sz="2800" dirty="0"/>
              <a:t>: The evolutionary history was inferred by using the Maximum Likelihood method and Kimura 2-parameter model. This analysis involved 38 nucleotide sequences.</a:t>
            </a:r>
            <a:br>
              <a:rPr lang="en-ZA" sz="2800" dirty="0"/>
            </a:br>
            <a:endParaRPr lang="en-ZA" sz="2800" dirty="0"/>
          </a:p>
        </p:txBody>
      </p:sp>
      <p:pic>
        <p:nvPicPr>
          <p:cNvPr id="4" name="image1.png">
            <a:extLst>
              <a:ext uri="{FF2B5EF4-FFF2-40B4-BE49-F238E27FC236}">
                <a16:creationId xmlns:a16="http://schemas.microsoft.com/office/drawing/2014/main" id="{87A755EE-16A3-4E0A-BCE6-A90160141FCC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>
          <a:xfrm>
            <a:off x="2231537" y="68387"/>
            <a:ext cx="7410872" cy="4351338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79530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   Supplementary Figure 3: The evolutionary history was inferred by using the Maximum Likelihood method and Kimura 2-parameter model. This analysis involved 38 nucleotide sequences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  Supplementary Figure 3: The evolutionary history was inferred by using the Maximum Likelihood method and Kimura 2-parameter model. This analysis involved 38 nucleotide sequences. </dc:title>
  <dc:creator>Prof. CT Sabeta</dc:creator>
  <cp:lastModifiedBy>Prof. CT Sabeta</cp:lastModifiedBy>
  <cp:revision>1</cp:revision>
  <dcterms:created xsi:type="dcterms:W3CDTF">2026-04-24T08:39:30Z</dcterms:created>
  <dcterms:modified xsi:type="dcterms:W3CDTF">2026-04-24T08:40:21Z</dcterms:modified>
</cp:coreProperties>
</file>